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70" r:id="rId2"/>
    <p:sldId id="266" r:id="rId3"/>
    <p:sldId id="257" r:id="rId4"/>
    <p:sldId id="264" r:id="rId5"/>
    <p:sldId id="279" r:id="rId6"/>
    <p:sldId id="269" r:id="rId7"/>
    <p:sldId id="280" r:id="rId8"/>
    <p:sldId id="271" r:id="rId9"/>
    <p:sldId id="281" r:id="rId10"/>
    <p:sldId id="278" r:id="rId11"/>
    <p:sldId id="283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448"/>
    <p:restoredTop sz="94674"/>
  </p:normalViewPr>
  <p:slideViewPr>
    <p:cSldViewPr snapToGrid="0" snapToObjects="1">
      <p:cViewPr varScale="1">
        <p:scale>
          <a:sx n="123" d="100"/>
          <a:sy n="123" d="100"/>
        </p:scale>
        <p:origin x="192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8171AB-5277-4551-98CE-3F974BC92AAF}" type="datetimeFigureOut">
              <a:rPr lang="en-US" smtClean="0"/>
              <a:t>6/1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0D4774-0075-4E80-A395-2210757918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409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450BB3-9762-4C14-8393-C4FC9EADBEC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9425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450BB3-9762-4C14-8393-C4FC9EADBEC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187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145D3-14B6-B244-AE13-98198598B7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9A793F-85A0-F447-A904-9CDB207994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55CF39-A55A-6B48-8FE5-54438A0DC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236F4E-CB53-AA4F-9BA4-F12B4E314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99660-E3A5-7546-8A7A-0B003382E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566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5424C-10C8-674E-9223-A59D56042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50644D-41FE-DF4B-9756-0DDFA9FBD6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86C31-7D05-F641-A125-24A3914AE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3458D6-1ECF-784B-859F-098EA2148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3BAD6-87D9-194C-93B4-B1ED16943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666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AF5BE2-0393-434C-912B-B4284F3D7F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23C9C9-170E-394F-AB2A-9A5452EF57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CF320-9EF4-444B-9F30-E861500E6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D1D458-0D73-2542-995A-6DC91FEEE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129B3-AF3D-9C4D-BE4A-418C46848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847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EFAAA-A6F0-1E4B-B8B8-BB202DE87C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BCCFF0-39F1-404C-8530-3678C4C34F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F1DF0-F8DF-964C-92A8-80C016D8E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33C832-1B5F-E04E-9DD2-E487C32C7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F51A9-7B32-554F-A85E-D1DB4B639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702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B9842-E5A4-CB4F-8430-D13A27DF4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558575-563A-184D-8228-E3532EDCF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2CF94-A126-F041-9448-AA219626B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F110C-3B32-054A-827F-B8BB72D6C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E7786E-6577-BA46-858F-5444EA59A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10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A4E84-8ACB-E14D-BCCF-0BFDC0512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E7A69-60FB-0549-BCEF-9B2D441598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D63B72-FFEF-CC48-A307-474D57C4B3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2A3A5A-A7A4-684E-94EA-77CF78C6E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732A58-D641-1741-AC02-7800AD4F3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D69A22-C75B-D245-939F-4FE3973A4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890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2FE4A0-41DB-E947-9335-B52F9D249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2CCA56-18B5-F34C-BDFA-EFFC760CDF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1A3FD9-1C6D-D348-B8FE-6F04D9E342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6A33C6-B20A-234C-9D47-0B82BA563C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21B6F6-F281-A44D-804B-BCA1BD5A14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208BBA8-3300-FA4B-ADB3-7244689E9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331DE78-6183-074E-B6D7-F085F3ED6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25EA2F-E3D7-7B48-BDC5-13FE79B2C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609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4B1A99-8448-8C4D-97D4-FEE0B73FC0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3C1352-069A-C341-BF1C-8DEAB6D4E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B7AF1C-4F8E-1443-A9F1-F02631217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A7B3D16-73B5-F947-9BDD-70653D8B8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400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76C933-6521-BE47-A3B5-167D2F0D6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C51472-88BF-A641-AF20-B816CCF82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7E5BAA-F8D6-1545-ADE5-D3C3508ED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842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2AD53-381C-3E47-9607-940393495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BDE96E-6C81-5642-825F-8734E2FEBC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CC2CEB-B64A-194E-9BF2-A38C9C034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6E2C2F-B173-8E44-88F5-F3C433C27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B7F13E-37E1-0C43-AA64-134933163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D02EAD-3C27-8941-940B-2C1FF279C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38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BD974-EFB2-2C4C-A8B6-AADED76CC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13B260-3079-FF45-B7B9-D50F609543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98B148-279B-3747-850D-ABEDF3AAC3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70B08A-70A2-B346-8AF0-62587846F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325D1C-4ACF-DA46-8BFE-8F5BDE2AE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63E221-590A-2E4B-AD58-182DEF3CC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310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EA672D-A3A8-244F-9A6F-769137795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C48E5C-2F3A-1440-9C44-404A6B635D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479101-F2F0-BC48-8B70-EF960C0291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E705C-A9A5-7940-ADAB-9E67EBAB135C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17589E-44EF-1A42-9D73-F8DFB89509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973F8A-7B86-A84E-B491-2423AD76B2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775B4-791A-9542-B7B4-BB035934E6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979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8F6C3D7A-E260-3644-B683-DAEEA3B0109B}"/>
              </a:ext>
            </a:extLst>
          </p:cNvPr>
          <p:cNvSpPr/>
          <p:nvPr/>
        </p:nvSpPr>
        <p:spPr>
          <a:xfrm>
            <a:off x="4369531" y="3598739"/>
            <a:ext cx="300114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ytoplasmic Staining,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H07-2x, cytoplasmic H-score 200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6D4C1B3-86EB-3C44-B53F-00156256C3A3}"/>
              </a:ext>
            </a:extLst>
          </p:cNvPr>
          <p:cNvSpPr txBox="1"/>
          <p:nvPr/>
        </p:nvSpPr>
        <p:spPr>
          <a:xfrm>
            <a:off x="10954624" y="6399211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0DB9301-0145-EB4E-A46E-64792007C4D3}"/>
              </a:ext>
            </a:extLst>
          </p:cNvPr>
          <p:cNvSpPr/>
          <p:nvPr/>
        </p:nvSpPr>
        <p:spPr>
          <a:xfrm>
            <a:off x="381809" y="3621730"/>
            <a:ext cx="288091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ytomembranous staining,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G-N-471x, overall H-score 270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EF77F1F-87A1-D541-B039-098751A2A3E2}"/>
              </a:ext>
            </a:extLst>
          </p:cNvPr>
          <p:cNvSpPr/>
          <p:nvPr/>
        </p:nvSpPr>
        <p:spPr>
          <a:xfrm>
            <a:off x="8725795" y="3624497"/>
            <a:ext cx="288091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ranuclear staining,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G-N-496x, overall H-score 180              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410283D2-8EE1-7643-831F-B481015A096B}"/>
              </a:ext>
            </a:extLst>
          </p:cNvPr>
          <p:cNvGrpSpPr/>
          <p:nvPr/>
        </p:nvGrpSpPr>
        <p:grpSpPr>
          <a:xfrm>
            <a:off x="213763" y="347656"/>
            <a:ext cx="11618848" cy="3081344"/>
            <a:chOff x="-12135" y="347656"/>
            <a:chExt cx="11618848" cy="3081344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8F679C9-1C1D-A742-A9FB-CB3ED11C0C6A}"/>
                </a:ext>
              </a:extLst>
            </p:cNvPr>
            <p:cNvSpPr txBox="1"/>
            <p:nvPr/>
          </p:nvSpPr>
          <p:spPr>
            <a:xfrm>
              <a:off x="-12135" y="347656"/>
              <a:ext cx="40267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82CA148-95E5-5344-961E-531483FEFE09}"/>
                </a:ext>
              </a:extLst>
            </p:cNvPr>
            <p:cNvSpPr txBox="1"/>
            <p:nvPr/>
          </p:nvSpPr>
          <p:spPr>
            <a:xfrm>
              <a:off x="3792023" y="347656"/>
              <a:ext cx="38664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D77D110-0B17-D242-91E7-2DADDB2B055B}"/>
                </a:ext>
              </a:extLst>
            </p:cNvPr>
            <p:cNvSpPr txBox="1"/>
            <p:nvPr/>
          </p:nvSpPr>
          <p:spPr>
            <a:xfrm>
              <a:off x="7637911" y="347656"/>
              <a:ext cx="37542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FAAE5D9-2CC2-C048-87AE-AA30510282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657" y="870876"/>
              <a:ext cx="3550049" cy="2558124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73A0B003-97DB-6340-90AB-31BEB99B074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2293" y="870876"/>
              <a:ext cx="3535618" cy="2558124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CFE8D317-38A3-FC4F-859E-3011F4C7599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71095" y="870876"/>
              <a:ext cx="3535618" cy="2558124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372207C-6029-5347-A0AE-736331BE7D54}"/>
                </a:ext>
              </a:extLst>
            </p:cNvPr>
            <p:cNvSpPr txBox="1"/>
            <p:nvPr/>
          </p:nvSpPr>
          <p:spPr>
            <a:xfrm>
              <a:off x="196398" y="2859110"/>
              <a:ext cx="644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50 um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C8FBD6B-BD8A-BB48-9B33-C41C569C848A}"/>
                </a:ext>
              </a:extLst>
            </p:cNvPr>
            <p:cNvSpPr txBox="1"/>
            <p:nvPr/>
          </p:nvSpPr>
          <p:spPr>
            <a:xfrm>
              <a:off x="4216647" y="2871331"/>
              <a:ext cx="644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50 um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EEA2EB4-369D-054C-BB05-1A2E090BEDEB}"/>
                </a:ext>
              </a:extLst>
            </p:cNvPr>
            <p:cNvSpPr txBox="1"/>
            <p:nvPr/>
          </p:nvSpPr>
          <p:spPr>
            <a:xfrm>
              <a:off x="8181194" y="2859109"/>
              <a:ext cx="644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50 um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01AF83D-096D-4C3F-77FB-BB80CF8FC302}"/>
              </a:ext>
            </a:extLst>
          </p:cNvPr>
          <p:cNvSpPr txBox="1"/>
          <p:nvPr/>
        </p:nvSpPr>
        <p:spPr>
          <a:xfrm>
            <a:off x="800100" y="4790209"/>
            <a:ext cx="101545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Representative images of DLL3 staining patterns and scoring in neuroblastoma PDXs. </a:t>
            </a:r>
            <a:r>
              <a:rPr lang="en-US" dirty="0"/>
              <a:t>including (A) mixed membranous accentuation in a subset of cell with more uniform cytoplasmic staining, (B) diffuse cytoplasmic staining, and (C) paranuclear staining with weaker cytoplasmic staining. Scale bar = 50um.</a:t>
            </a:r>
          </a:p>
        </p:txBody>
      </p:sp>
    </p:spTree>
    <p:extLst>
      <p:ext uri="{BB962C8B-B14F-4D97-AF65-F5344CB8AC3E}">
        <p14:creationId xmlns:p14="http://schemas.microsoft.com/office/powerpoint/2010/main" val="3618825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947616-DEB8-8940-830C-620F79F9DD17}"/>
              </a:ext>
            </a:extLst>
          </p:cNvPr>
          <p:cNvSpPr txBox="1"/>
          <p:nvPr/>
        </p:nvSpPr>
        <p:spPr>
          <a:xfrm>
            <a:off x="10563776" y="6450408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7A9DC19-9A68-2B46-905F-4A4FE349BC2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30" r="4130"/>
          <a:stretch/>
        </p:blipFill>
        <p:spPr>
          <a:xfrm rot="5400000">
            <a:off x="2297684" y="-1408090"/>
            <a:ext cx="6858000" cy="9674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66849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7FF898-FE9D-095E-3C0A-283FC9290767}"/>
              </a:ext>
            </a:extLst>
          </p:cNvPr>
          <p:cNvSpPr txBox="1"/>
          <p:nvPr/>
        </p:nvSpPr>
        <p:spPr>
          <a:xfrm>
            <a:off x="1704109" y="1745673"/>
            <a:ext cx="878378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7. </a:t>
            </a:r>
            <a:r>
              <a:rPr lang="en-US" b="1" dirty="0" err="1"/>
              <a:t>Rova</a:t>
            </a:r>
            <a:r>
              <a:rPr lang="en-US" b="1" dirty="0"/>
              <a:t>-T anti-tumor activity in DLL3-expressing neuroblastoma PDX models.</a:t>
            </a:r>
            <a:r>
              <a:rPr lang="en-US" dirty="0"/>
              <a:t> The in vivo efficacy of </a:t>
            </a:r>
            <a:r>
              <a:rPr lang="en-US" dirty="0" err="1"/>
              <a:t>Rova</a:t>
            </a:r>
            <a:r>
              <a:rPr lang="en-US" dirty="0"/>
              <a:t>-T was evaluated in female CB17 SCID mice bearing </a:t>
            </a:r>
            <a:r>
              <a:rPr lang="en-US" b="1" dirty="0"/>
              <a:t>A) </a:t>
            </a:r>
            <a:r>
              <a:rPr lang="en-US" dirty="0"/>
              <a:t>SK-N-AS;</a:t>
            </a:r>
            <a:r>
              <a:rPr lang="en-US" b="1" dirty="0"/>
              <a:t> (B) </a:t>
            </a:r>
            <a:r>
              <a:rPr lang="en-US" dirty="0"/>
              <a:t>NB-FLY-623m,</a:t>
            </a:r>
            <a:r>
              <a:rPr lang="en-US" b="1" dirty="0"/>
              <a:t> (C) </a:t>
            </a:r>
            <a:r>
              <a:rPr lang="en-US" dirty="0"/>
              <a:t>KWK-6062x,</a:t>
            </a:r>
            <a:r>
              <a:rPr lang="en-US" b="1" dirty="0"/>
              <a:t> (D) </a:t>
            </a:r>
            <a:r>
              <a:rPr lang="en-US" dirty="0"/>
              <a:t>COG-N-421x, </a:t>
            </a:r>
            <a:r>
              <a:rPr lang="en-US" b="1" dirty="0"/>
              <a:t>(E)</a:t>
            </a:r>
            <a:r>
              <a:rPr lang="en-US" dirty="0"/>
              <a:t> SH-SY5Y and </a:t>
            </a:r>
            <a:r>
              <a:rPr lang="en-US" b="1" dirty="0"/>
              <a:t>(F)</a:t>
            </a:r>
            <a:r>
              <a:rPr lang="en-US" dirty="0"/>
              <a:t> COG-N-424x PDXs and xenografts. Upon enrollment, mice (n=2 per group) were intraperitoneally injected with 5% glucose water (vehicle control), or </a:t>
            </a:r>
            <a:r>
              <a:rPr lang="en-US" dirty="0" err="1"/>
              <a:t>Rova</a:t>
            </a:r>
            <a:r>
              <a:rPr lang="en-US" dirty="0"/>
              <a:t>-T at 0.1 mg/kg and/or 0.6 mg/kg. Differences in event-free survival (EFS) between experimental groups (e.g., treated vs controls) are tested using the </a:t>
            </a:r>
            <a:r>
              <a:rPr lang="en-US" dirty="0" err="1"/>
              <a:t>Peto</a:t>
            </a:r>
            <a:r>
              <a:rPr lang="en-US" dirty="0"/>
              <a:t> and </a:t>
            </a:r>
            <a:r>
              <a:rPr lang="en-US" dirty="0" err="1"/>
              <a:t>Peto</a:t>
            </a:r>
            <a:r>
              <a:rPr lang="en-US" dirty="0"/>
              <a:t> modification of the </a:t>
            </a:r>
            <a:r>
              <a:rPr lang="en-US" dirty="0" err="1"/>
              <a:t>Gehan</a:t>
            </a:r>
            <a:r>
              <a:rPr lang="en-US" dirty="0"/>
              <a:t>-Wilcoxon test (</a:t>
            </a:r>
            <a:r>
              <a:rPr lang="en-US" i="1" dirty="0"/>
              <a:t>α</a:t>
            </a:r>
            <a:r>
              <a:rPr lang="en-US" dirty="0"/>
              <a:t> = 0.05, two-sided alternative) and plotted as Kaplan-Meier event-free-survival (EFS) curves.</a:t>
            </a:r>
          </a:p>
        </p:txBody>
      </p:sp>
    </p:spTree>
    <p:extLst>
      <p:ext uri="{BB962C8B-B14F-4D97-AF65-F5344CB8AC3E}">
        <p14:creationId xmlns:p14="http://schemas.microsoft.com/office/powerpoint/2010/main" val="2170560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956D4C8-FE7E-9648-9081-D3DBCCF1794E}"/>
              </a:ext>
            </a:extLst>
          </p:cNvPr>
          <p:cNvSpPr txBox="1"/>
          <p:nvPr/>
        </p:nvSpPr>
        <p:spPr>
          <a:xfrm>
            <a:off x="10350230" y="6371617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9E6D2CD8-C4B8-474E-A5DC-7A6233ACD5D5}"/>
              </a:ext>
            </a:extLst>
          </p:cNvPr>
          <p:cNvGrpSpPr/>
          <p:nvPr/>
        </p:nvGrpSpPr>
        <p:grpSpPr>
          <a:xfrm>
            <a:off x="1358559" y="421864"/>
            <a:ext cx="9225846" cy="5035790"/>
            <a:chOff x="1124383" y="360029"/>
            <a:chExt cx="9225846" cy="503579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EB0DD226-E950-7741-986D-FE87D104F40F}"/>
                </a:ext>
              </a:extLst>
            </p:cNvPr>
            <p:cNvGrpSpPr/>
            <p:nvPr/>
          </p:nvGrpSpPr>
          <p:grpSpPr>
            <a:xfrm>
              <a:off x="1124383" y="408555"/>
              <a:ext cx="4604662" cy="4987264"/>
              <a:chOff x="1124383" y="408555"/>
              <a:chExt cx="4604662" cy="4987264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4567E9F8-5D84-9141-9BC8-4D71CCE578FD}"/>
                  </a:ext>
                </a:extLst>
              </p:cNvPr>
              <p:cNvGrpSpPr/>
              <p:nvPr/>
            </p:nvGrpSpPr>
            <p:grpSpPr>
              <a:xfrm>
                <a:off x="1124383" y="408555"/>
                <a:ext cx="4604662" cy="4987264"/>
                <a:chOff x="6105592" y="54106"/>
                <a:chExt cx="3932606" cy="4316566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9129E7C7-ED8A-2241-8498-3CF7CA403DC4}"/>
                    </a:ext>
                  </a:extLst>
                </p:cNvPr>
                <p:cNvSpPr txBox="1"/>
                <p:nvPr/>
              </p:nvSpPr>
              <p:spPr>
                <a:xfrm>
                  <a:off x="6105592" y="3917816"/>
                  <a:ext cx="3932606" cy="452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uroblastoma Primary Tumor Array </a:t>
                  </a:r>
                </a:p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nti-DLL3 (SP347)</a:t>
                  </a:r>
                </a:p>
              </p:txBody>
            </p:sp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F56A0F9B-76FE-034C-8A55-5DC2F10503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105592" y="54106"/>
                  <a:ext cx="3932606" cy="3617489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</p:grp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2DB197A-561F-194B-BA60-7D2E3DB826A3}"/>
                  </a:ext>
                </a:extLst>
              </p:cNvPr>
              <p:cNvSpPr txBox="1"/>
              <p:nvPr/>
            </p:nvSpPr>
            <p:spPr>
              <a:xfrm>
                <a:off x="1471501" y="4049809"/>
                <a:ext cx="638537" cy="3200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 mm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DAFCD69F-B8E1-874F-BA43-74D5E8FFA007}"/>
                </a:ext>
              </a:extLst>
            </p:cNvPr>
            <p:cNvGrpSpPr/>
            <p:nvPr/>
          </p:nvGrpSpPr>
          <p:grpSpPr>
            <a:xfrm>
              <a:off x="6767921" y="360029"/>
              <a:ext cx="3582308" cy="5035789"/>
              <a:chOff x="6767921" y="360029"/>
              <a:chExt cx="3582308" cy="5035789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05BA441-86AB-5047-A66B-4E5AD629E2F9}"/>
                  </a:ext>
                </a:extLst>
              </p:cNvPr>
              <p:cNvGrpSpPr/>
              <p:nvPr/>
            </p:nvGrpSpPr>
            <p:grpSpPr>
              <a:xfrm>
                <a:off x="6767921" y="360029"/>
                <a:ext cx="3582308" cy="5035789"/>
                <a:chOff x="7882075" y="-1909"/>
                <a:chExt cx="3059466" cy="4358566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32B9F9E6-B5EC-C34E-8B27-11A60370B545}"/>
                    </a:ext>
                  </a:extLst>
                </p:cNvPr>
                <p:cNvSpPr txBox="1"/>
                <p:nvPr/>
              </p:nvSpPr>
              <p:spPr>
                <a:xfrm>
                  <a:off x="7882075" y="3903801"/>
                  <a:ext cx="3059466" cy="452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ormal Childhood Tissue Array</a:t>
                  </a:r>
                </a:p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nti-DLL3 (SP347)</a:t>
                  </a:r>
                </a:p>
              </p:txBody>
            </p:sp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7F506BB5-4A8A-DC49-934E-8BAD01BCD0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7882075" y="-1909"/>
                  <a:ext cx="3059466" cy="3659488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056F64A-97CF-5546-8470-B48C4013DB3A}"/>
                  </a:ext>
                </a:extLst>
              </p:cNvPr>
              <p:cNvSpPr txBox="1"/>
              <p:nvPr/>
            </p:nvSpPr>
            <p:spPr>
              <a:xfrm>
                <a:off x="7102053" y="4250302"/>
                <a:ext cx="638537" cy="3200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 mm</a:t>
                </a:r>
              </a:p>
            </p:txBody>
          </p: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B792A4B6-8CDE-841D-9C66-D89AED1617F4}"/>
              </a:ext>
            </a:extLst>
          </p:cNvPr>
          <p:cNvSpPr txBox="1"/>
          <p:nvPr/>
        </p:nvSpPr>
        <p:spPr>
          <a:xfrm>
            <a:off x="547255" y="5671820"/>
            <a:ext cx="103839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 DLL3 staining of human neuroblastoma and normal human tissue TMAs. </a:t>
            </a:r>
            <a:r>
              <a:rPr lang="en-US" dirty="0"/>
              <a:t>Immunohistochemistry with rabbit anti-DLL3 SP347 (Ventana, 790-7016) antibody was performed on formalin fixed paraffin embedded TMA slides. Full TMA slide images are shown (scale bars = 3 mm).</a:t>
            </a:r>
          </a:p>
        </p:txBody>
      </p:sp>
    </p:spTree>
    <p:extLst>
      <p:ext uri="{BB962C8B-B14F-4D97-AF65-F5344CB8AC3E}">
        <p14:creationId xmlns:p14="http://schemas.microsoft.com/office/powerpoint/2010/main" val="42512629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17DD587-CD65-CA21-0AAC-E6314673FC5F}"/>
              </a:ext>
            </a:extLst>
          </p:cNvPr>
          <p:cNvGrpSpPr/>
          <p:nvPr/>
        </p:nvGrpSpPr>
        <p:grpSpPr>
          <a:xfrm>
            <a:off x="0" y="111564"/>
            <a:ext cx="11994875" cy="5526968"/>
            <a:chOff x="0" y="485640"/>
            <a:chExt cx="11994875" cy="5526968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3D887902-9C9F-324E-99FF-AFFBC6BE18A2}"/>
                </a:ext>
              </a:extLst>
            </p:cNvPr>
            <p:cNvSpPr/>
            <p:nvPr/>
          </p:nvSpPr>
          <p:spPr>
            <a:xfrm>
              <a:off x="5898875" y="5366277"/>
              <a:ext cx="6096000" cy="646331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NB Human TMA </a:t>
              </a:r>
            </a:p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nti-DLL3 (SP347)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8322129-7D79-A147-B946-8FE68B0A1851}"/>
                </a:ext>
              </a:extLst>
            </p:cNvPr>
            <p:cNvSpPr/>
            <p:nvPr/>
          </p:nvSpPr>
          <p:spPr>
            <a:xfrm>
              <a:off x="0" y="5353434"/>
              <a:ext cx="6096000" cy="646331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NB Human TMA </a:t>
              </a:r>
            </a:p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nti-CD56 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121E3B2B-5FB1-9444-B715-62AF4E004A8A}"/>
                </a:ext>
              </a:extLst>
            </p:cNvPr>
            <p:cNvSpPr/>
            <p:nvPr/>
          </p:nvSpPr>
          <p:spPr>
            <a:xfrm>
              <a:off x="6699643" y="485640"/>
              <a:ext cx="368421" cy="37649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7C6BF46-71C9-4A4E-9108-F16F58FB66C6}"/>
                </a:ext>
              </a:extLst>
            </p:cNvPr>
            <p:cNvSpPr txBox="1"/>
            <p:nvPr/>
          </p:nvSpPr>
          <p:spPr>
            <a:xfrm>
              <a:off x="8817179" y="1087820"/>
              <a:ext cx="400962" cy="347885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BA6122F-D8B4-5444-8A24-2650702BD3FB}"/>
                </a:ext>
              </a:extLst>
            </p:cNvPr>
            <p:cNvSpPr txBox="1"/>
            <p:nvPr/>
          </p:nvSpPr>
          <p:spPr>
            <a:xfrm rot="5400000">
              <a:off x="9359103" y="2943659"/>
              <a:ext cx="448544" cy="38443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1C1E56B1-9589-D441-8B11-9D54219FA809}"/>
                </a:ext>
              </a:extLst>
            </p:cNvPr>
            <p:cNvGrpSpPr/>
            <p:nvPr/>
          </p:nvGrpSpPr>
          <p:grpSpPr>
            <a:xfrm>
              <a:off x="6388188" y="485641"/>
              <a:ext cx="5117374" cy="4683212"/>
              <a:chOff x="6388188" y="485641"/>
              <a:chExt cx="5117374" cy="4683212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A5C6F58A-368A-D74B-9CCF-29CBB4CD3B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482" b="7082"/>
              <a:stretch/>
            </p:blipFill>
            <p:spPr>
              <a:xfrm rot="5400000">
                <a:off x="6605269" y="268560"/>
                <a:ext cx="4683212" cy="5117374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76A7846-42F6-AF48-B076-56A653BBC579}"/>
                  </a:ext>
                </a:extLst>
              </p:cNvPr>
              <p:cNvSpPr txBox="1"/>
              <p:nvPr/>
            </p:nvSpPr>
            <p:spPr>
              <a:xfrm>
                <a:off x="6868729" y="4644800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 mm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0EAA10A-9D36-494A-BEE3-531D44C0C92D}"/>
                </a:ext>
              </a:extLst>
            </p:cNvPr>
            <p:cNvGrpSpPr/>
            <p:nvPr/>
          </p:nvGrpSpPr>
          <p:grpSpPr>
            <a:xfrm>
              <a:off x="665325" y="485641"/>
              <a:ext cx="5008600" cy="4722770"/>
              <a:chOff x="665325" y="485641"/>
              <a:chExt cx="5008600" cy="4722770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C5958E4A-A39F-D649-B08A-5E630EA8C503}"/>
                  </a:ext>
                </a:extLst>
              </p:cNvPr>
              <p:cNvGrpSpPr/>
              <p:nvPr/>
            </p:nvGrpSpPr>
            <p:grpSpPr>
              <a:xfrm>
                <a:off x="665325" y="485641"/>
                <a:ext cx="5008600" cy="4683211"/>
                <a:chOff x="665325" y="485641"/>
                <a:chExt cx="5008600" cy="4683211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7EDDFB2E-F5FF-6E42-B4D2-FEE625EAAF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190" r="1888" b="9730"/>
                <a:stretch/>
              </p:blipFill>
              <p:spPr>
                <a:xfrm rot="5400000">
                  <a:off x="828019" y="322947"/>
                  <a:ext cx="4683211" cy="5008600"/>
                </a:xfrm>
                <a:prstGeom prst="rect">
                  <a:avLst/>
                </a:prstGeom>
                <a:ln w="28575">
                  <a:solidFill>
                    <a:schemeClr val="tx1"/>
                  </a:solidFill>
                </a:ln>
              </p:spPr>
            </p:pic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331602BF-F473-48CF-9E61-6F8BB29EAA5D}"/>
                    </a:ext>
                  </a:extLst>
                </p:cNvPr>
                <p:cNvSpPr/>
                <p:nvPr/>
              </p:nvSpPr>
              <p:spPr>
                <a:xfrm>
                  <a:off x="826066" y="581712"/>
                  <a:ext cx="344135" cy="411676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CBDF0CD7-7F60-464D-A0BD-84753F8EE9E3}"/>
                    </a:ext>
                  </a:extLst>
                </p:cNvPr>
                <p:cNvSpPr txBox="1"/>
                <p:nvPr/>
              </p:nvSpPr>
              <p:spPr>
                <a:xfrm>
                  <a:off x="3061252" y="993388"/>
                  <a:ext cx="417445" cy="3648186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53F149E-C6D6-DD4B-A663-C82D9C86056B}"/>
                    </a:ext>
                  </a:extLst>
                </p:cNvPr>
                <p:cNvSpPr txBox="1"/>
                <p:nvPr/>
              </p:nvSpPr>
              <p:spPr>
                <a:xfrm rot="5400000">
                  <a:off x="3791299" y="3285687"/>
                  <a:ext cx="378966" cy="3229894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04E60A90-C443-8D45-8021-0A0D1D9697A3}"/>
                  </a:ext>
                </a:extLst>
              </p:cNvPr>
              <p:cNvSpPr txBox="1"/>
              <p:nvPr/>
            </p:nvSpPr>
            <p:spPr>
              <a:xfrm>
                <a:off x="1047665" y="4900634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 mm</a:t>
                </a:r>
              </a:p>
            </p:txBody>
          </p: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A49778D5-64C5-403F-9279-98217F17B2FB}"/>
              </a:ext>
            </a:extLst>
          </p:cNvPr>
          <p:cNvSpPr txBox="1"/>
          <p:nvPr/>
        </p:nvSpPr>
        <p:spPr>
          <a:xfrm>
            <a:off x="10350230" y="6371617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1883CF-9329-C628-FD21-8FBA219771E7}"/>
              </a:ext>
            </a:extLst>
          </p:cNvPr>
          <p:cNvSpPr txBox="1"/>
          <p:nvPr/>
        </p:nvSpPr>
        <p:spPr>
          <a:xfrm>
            <a:off x="402237" y="5756064"/>
            <a:ext cx="1099327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DLL3 and NCAM(CD56) staining of human neuroblastoma TMA.</a:t>
            </a:r>
            <a:r>
              <a:rPr lang="en-US" dirty="0"/>
              <a:t> Immunohistochemistry with rabbit anti-DLL3 SP347 (Ventana, 790-7016) and NCAM (CD56) (Cell Marque, 156-R-95) antibodies was performed on formalin fixed paraffin embedded TMA slides. Full TMA slide images are shown (scale bars = 3 mm).</a:t>
            </a:r>
          </a:p>
        </p:txBody>
      </p:sp>
    </p:spTree>
    <p:extLst>
      <p:ext uri="{BB962C8B-B14F-4D97-AF65-F5344CB8AC3E}">
        <p14:creationId xmlns:p14="http://schemas.microsoft.com/office/powerpoint/2010/main" val="552628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0D553B9-A2C1-EE46-AF59-5498E94A1EBA}"/>
              </a:ext>
            </a:extLst>
          </p:cNvPr>
          <p:cNvSpPr txBox="1"/>
          <p:nvPr/>
        </p:nvSpPr>
        <p:spPr>
          <a:xfrm>
            <a:off x="10651787" y="6429983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pic>
        <p:nvPicPr>
          <p:cNvPr id="7" name="Picture 6" descr="Graphical user interface, application, table, Excel&#10;&#10;Description automatically generated">
            <a:extLst>
              <a:ext uri="{FF2B5EF4-FFF2-40B4-BE49-F238E27FC236}">
                <a16:creationId xmlns:a16="http://schemas.microsoft.com/office/drawing/2014/main" id="{02EA6ED6-22E2-0C45-9091-5FC235E0E9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7529" y="284871"/>
            <a:ext cx="8348034" cy="6288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4917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CEB6D12-D3B8-F0A9-06C4-D67CA5221C3F}"/>
              </a:ext>
            </a:extLst>
          </p:cNvPr>
          <p:cNvSpPr txBox="1"/>
          <p:nvPr/>
        </p:nvSpPr>
        <p:spPr>
          <a:xfrm>
            <a:off x="2130136" y="2317173"/>
            <a:ext cx="712816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Normal human tissue TMA key. </a:t>
            </a:r>
            <a:r>
              <a:rPr lang="en-US" dirty="0"/>
              <a:t>The Normal Human TMA was constructed with 41 different tissue types/organs between the ages of 0-343 months punched in duplicate. All tissue samples were classified histologically as normal.</a:t>
            </a:r>
          </a:p>
        </p:txBody>
      </p:sp>
    </p:spTree>
    <p:extLst>
      <p:ext uri="{BB962C8B-B14F-4D97-AF65-F5344CB8AC3E}">
        <p14:creationId xmlns:p14="http://schemas.microsoft.com/office/powerpoint/2010/main" val="653103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9917AC4-3186-254B-A15D-E1C37828BA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3" t="15797" r="6488" b="16377"/>
          <a:stretch/>
        </p:blipFill>
        <p:spPr>
          <a:xfrm>
            <a:off x="2505006" y="3500355"/>
            <a:ext cx="2634250" cy="26755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C220FA1-869F-3E4E-8A99-DD58FB83D205}"/>
              </a:ext>
            </a:extLst>
          </p:cNvPr>
          <p:cNvSpPr/>
          <p:nvPr/>
        </p:nvSpPr>
        <p:spPr>
          <a:xfrm>
            <a:off x="6053648" y="2959665"/>
            <a:ext cx="287367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/>
              <a:t>COG-N-452x </a:t>
            </a:r>
          </a:p>
          <a:p>
            <a:r>
              <a:rPr lang="en-US" sz="1400" dirty="0"/>
              <a:t>H-score: overall 200, membrane 200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C22EADA-E1CC-5448-ABAF-0896F9E44283}"/>
              </a:ext>
            </a:extLst>
          </p:cNvPr>
          <p:cNvSpPr/>
          <p:nvPr/>
        </p:nvSpPr>
        <p:spPr>
          <a:xfrm>
            <a:off x="2375391" y="2962131"/>
            <a:ext cx="283359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/>
              <a:t>Felix-PDX </a:t>
            </a:r>
          </a:p>
          <a:p>
            <a:r>
              <a:rPr lang="en-US" sz="1400" dirty="0"/>
              <a:t>H-score: overall 300, membrane 2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6D4C1B3-86EB-3C44-B53F-00156256C3A3}"/>
              </a:ext>
            </a:extLst>
          </p:cNvPr>
          <p:cNvSpPr txBox="1"/>
          <p:nvPr/>
        </p:nvSpPr>
        <p:spPr>
          <a:xfrm>
            <a:off x="10871456" y="6348458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CEC0DD3-563D-214F-9A07-FB079ECC6200}"/>
              </a:ext>
            </a:extLst>
          </p:cNvPr>
          <p:cNvSpPr/>
          <p:nvPr/>
        </p:nvSpPr>
        <p:spPr>
          <a:xfrm>
            <a:off x="6093723" y="6279096"/>
            <a:ext cx="283359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/>
              <a:t>COG-N-519x </a:t>
            </a:r>
          </a:p>
          <a:p>
            <a:r>
              <a:rPr lang="en-US" sz="1400" dirty="0"/>
              <a:t>H-score: overall 300, membrane 18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0D91805-2851-E24C-AB4A-ADC3F70F91CA}"/>
              </a:ext>
            </a:extLst>
          </p:cNvPr>
          <p:cNvSpPr/>
          <p:nvPr/>
        </p:nvSpPr>
        <p:spPr>
          <a:xfrm>
            <a:off x="2385296" y="6279096"/>
            <a:ext cx="287367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/>
              <a:t>COG-N-415x </a:t>
            </a:r>
          </a:p>
          <a:p>
            <a:r>
              <a:rPr lang="en-US" sz="1400" dirty="0"/>
              <a:t>H-score: overall 200, membrane 120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5F55179-1CD4-D14B-A920-3743A923C56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0" t="16088" r="6926" b="16666"/>
          <a:stretch/>
        </p:blipFill>
        <p:spPr>
          <a:xfrm>
            <a:off x="6196496" y="264292"/>
            <a:ext cx="2634250" cy="26571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AF5F963-CD87-3A4B-8ECA-1A075309A1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0" t="17246" r="6925" b="16087"/>
          <a:stretch/>
        </p:blipFill>
        <p:spPr>
          <a:xfrm>
            <a:off x="6196496" y="3559879"/>
            <a:ext cx="2628050" cy="26571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DC896E08-F153-9B40-AE68-0BF07FE7F9F4}"/>
              </a:ext>
            </a:extLst>
          </p:cNvPr>
          <p:cNvGrpSpPr/>
          <p:nvPr/>
        </p:nvGrpSpPr>
        <p:grpSpPr>
          <a:xfrm>
            <a:off x="2505006" y="311315"/>
            <a:ext cx="2634250" cy="2657157"/>
            <a:chOff x="2443606" y="207074"/>
            <a:chExt cx="2861564" cy="287937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AFA696B-2E67-A54F-850E-4192761E28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75" t="15942" r="7093" b="16231"/>
            <a:stretch/>
          </p:blipFill>
          <p:spPr>
            <a:xfrm>
              <a:off x="2443606" y="207074"/>
              <a:ext cx="2861564" cy="287937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207871C-30C6-104F-A73C-D8FAD0165272}"/>
                </a:ext>
              </a:extLst>
            </p:cNvPr>
            <p:cNvSpPr txBox="1"/>
            <p:nvPr/>
          </p:nvSpPr>
          <p:spPr>
            <a:xfrm>
              <a:off x="2637142" y="2544381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0 um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C61EC41B-B18A-FB47-A2DD-A59C99591848}"/>
              </a:ext>
            </a:extLst>
          </p:cNvPr>
          <p:cNvSpPr txBox="1"/>
          <p:nvPr/>
        </p:nvSpPr>
        <p:spPr>
          <a:xfrm>
            <a:off x="6326433" y="2415226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0 u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35F1E7-18F6-0E49-B51E-70B99FD7605C}"/>
              </a:ext>
            </a:extLst>
          </p:cNvPr>
          <p:cNvSpPr txBox="1"/>
          <p:nvPr/>
        </p:nvSpPr>
        <p:spPr>
          <a:xfrm>
            <a:off x="2683168" y="574763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0 u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571DCE-7BAB-1342-8DBF-0FC10210BF5E}"/>
              </a:ext>
            </a:extLst>
          </p:cNvPr>
          <p:cNvSpPr txBox="1"/>
          <p:nvPr/>
        </p:nvSpPr>
        <p:spPr>
          <a:xfrm>
            <a:off x="6342821" y="574763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0 um</a:t>
            </a:r>
          </a:p>
        </p:txBody>
      </p:sp>
    </p:spTree>
    <p:extLst>
      <p:ext uri="{BB962C8B-B14F-4D97-AF65-F5344CB8AC3E}">
        <p14:creationId xmlns:p14="http://schemas.microsoft.com/office/powerpoint/2010/main" val="15114518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465B24D-A77E-1D75-AD59-C673D0A7F697}"/>
              </a:ext>
            </a:extLst>
          </p:cNvPr>
          <p:cNvSpPr txBox="1"/>
          <p:nvPr/>
        </p:nvSpPr>
        <p:spPr>
          <a:xfrm>
            <a:off x="1908463" y="2234045"/>
            <a:ext cx="83750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5. DLL3 staining in four PDX models tested for </a:t>
            </a:r>
            <a:r>
              <a:rPr lang="en-US" b="1" dirty="0" err="1"/>
              <a:t>Rova</a:t>
            </a:r>
            <a:r>
              <a:rPr lang="en-US" b="1" dirty="0"/>
              <a:t>-T efficacy </a:t>
            </a:r>
            <a:r>
              <a:rPr lang="en-US" b="1" i="1" dirty="0"/>
              <a:t>in vivo </a:t>
            </a:r>
            <a:r>
              <a:rPr lang="en-US" dirty="0"/>
              <a:t>showing high overall staining and generally more moderate membranous specific scores due to membrane-specific localization in a smaller subset of cells. Scale bar=200um.</a:t>
            </a:r>
          </a:p>
        </p:txBody>
      </p:sp>
    </p:spTree>
    <p:extLst>
      <p:ext uri="{BB962C8B-B14F-4D97-AF65-F5344CB8AC3E}">
        <p14:creationId xmlns:p14="http://schemas.microsoft.com/office/powerpoint/2010/main" val="24731708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182" y="0"/>
            <a:ext cx="12082818" cy="67581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F947616-DEB8-8940-830C-620F79F9DD17}"/>
              </a:ext>
            </a:extLst>
          </p:cNvPr>
          <p:cNvSpPr txBox="1"/>
          <p:nvPr/>
        </p:nvSpPr>
        <p:spPr>
          <a:xfrm>
            <a:off x="10563776" y="6450408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6904548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236A825-3482-A779-9B8E-AD2D2C218FCF}"/>
              </a:ext>
            </a:extLst>
          </p:cNvPr>
          <p:cNvSpPr txBox="1"/>
          <p:nvPr/>
        </p:nvSpPr>
        <p:spPr>
          <a:xfrm>
            <a:off x="1622713" y="2047009"/>
            <a:ext cx="894657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6. Analysis of mouse body weight throughout the course of treatment in n=8-10 studies. (A) </a:t>
            </a:r>
            <a:r>
              <a:rPr lang="en-US" dirty="0"/>
              <a:t>COG-N-452x;</a:t>
            </a:r>
            <a:r>
              <a:rPr lang="en-US" b="1" dirty="0"/>
              <a:t> (B) </a:t>
            </a:r>
            <a:r>
              <a:rPr lang="en-US" dirty="0"/>
              <a:t>Felix PDX,</a:t>
            </a:r>
            <a:r>
              <a:rPr lang="en-US" b="1" dirty="0"/>
              <a:t> (C) </a:t>
            </a:r>
            <a:r>
              <a:rPr lang="en-US" dirty="0"/>
              <a:t>COG-N-519x,</a:t>
            </a:r>
            <a:r>
              <a:rPr lang="en-US" b="1" dirty="0"/>
              <a:t> (D) </a:t>
            </a:r>
            <a:r>
              <a:rPr lang="en-US" dirty="0"/>
              <a:t>COG-N-415x (1 injection), (E) COG-N-415x (1 and 3 injections) PDX-bearing mice were treated with the following:</a:t>
            </a:r>
            <a:r>
              <a:rPr lang="en-US" b="1" dirty="0"/>
              <a:t> </a:t>
            </a:r>
            <a:r>
              <a:rPr lang="en-US" dirty="0"/>
              <a:t>vehicle control, IgG1-ADC at 0.6 mg/kg and 1 mg/kg or </a:t>
            </a:r>
            <a:r>
              <a:rPr lang="en-US" dirty="0" err="1"/>
              <a:t>Rova</a:t>
            </a:r>
            <a:r>
              <a:rPr lang="en-US" dirty="0"/>
              <a:t>-T at 0.1 mg/kg, 0.3 mg/kg, 0.6 mg/kg, or 1 mg/kg. Results are expressed as absolute body weight measurements as a function of time shown as days post treatment initiat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9827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01</TotalTime>
  <Words>636</Words>
  <Application>Microsoft Macintosh PowerPoint</Application>
  <PresentationFormat>Widescreen</PresentationFormat>
  <Paragraphs>52</Paragraphs>
  <Slides>1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osse, Yael P</cp:lastModifiedBy>
  <cp:revision>75</cp:revision>
  <dcterms:created xsi:type="dcterms:W3CDTF">2019-05-20T19:28:48Z</dcterms:created>
  <dcterms:modified xsi:type="dcterms:W3CDTF">2022-06-17T17:01:52Z</dcterms:modified>
</cp:coreProperties>
</file>